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7FBAFF-EB44-4258-83DE-B10C5BC6C92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104424-43C3-411C-952F-8CA4F5ABD1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B8F9A2-43F1-457A-AAFC-356617FCB8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410DE5-33F4-4BF8-BBAF-1A2B0D14ED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F517A7-CDE8-4E1C-BD98-12C173BF7B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C1E773-7EB7-46B1-AEEF-F8E6E00344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242189-26BD-4F74-8F6D-AAAD8E20C0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21FAD3-D48B-431B-A777-A4C203ED57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3E2CC-7678-42D0-B412-970555A134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036C50-9D56-41DB-A36F-409A554225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C20103-6162-4345-AD71-ED2F90E464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3DB618-D228-4780-B887-1F1281E1ED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0B54F54-D857-4475-B085-41AACE6310E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6048" r="0" b="0"/>
          <a:stretch/>
        </p:blipFill>
        <p:spPr>
          <a:xfrm>
            <a:off x="620640" y="2144880"/>
            <a:ext cx="5373720" cy="42084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33360" y="6824520"/>
            <a:ext cx="62643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2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Xenoarray analysis on library-transduced MDCK cells before (x-axis) and after (y-axis) a replicate selection performed on the first infection. The red circle highlights the area where enriched cDNAs can be foun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773360" y="2649600"/>
            <a:ext cx="734760" cy="1671480"/>
          </a:xfrm>
          <a:custGeom>
            <a:avLst/>
            <a:gdLst/>
            <a:ahLst/>
            <a:rect l="l" t="t" r="r" b="b"/>
            <a:pathLst>
              <a:path w="463" h="917">
                <a:moveTo>
                  <a:pt x="53" y="827"/>
                </a:moveTo>
                <a:cubicBezTo>
                  <a:pt x="106" y="917"/>
                  <a:pt x="333" y="751"/>
                  <a:pt x="398" y="665"/>
                </a:cubicBezTo>
                <a:cubicBezTo>
                  <a:pt x="463" y="579"/>
                  <a:pt x="450" y="411"/>
                  <a:pt x="442" y="310"/>
                </a:cubicBezTo>
                <a:cubicBezTo>
                  <a:pt x="434" y="209"/>
                  <a:pt x="410" y="89"/>
                  <a:pt x="350" y="59"/>
                </a:cubicBezTo>
                <a:cubicBezTo>
                  <a:pt x="290" y="29"/>
                  <a:pt x="128" y="0"/>
                  <a:pt x="79" y="128"/>
                </a:cubicBezTo>
                <a:cubicBezTo>
                  <a:pt x="30" y="256"/>
                  <a:pt x="0" y="737"/>
                  <a:pt x="53" y="827"/>
                </a:cubicBezTo>
                <a:close/>
              </a:path>
            </a:pathLst>
          </a:custGeom>
          <a:noFill/>
          <a:ln w="2844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30T13:44:08Z</dcterms:created>
  <dc:creator>emedico</dc:creator>
  <dc:description/>
  <dc:language>en-US</dc:language>
  <cp:lastModifiedBy>emedico</cp:lastModifiedBy>
  <dcterms:modified xsi:type="dcterms:W3CDTF">2008-05-29T13:11:08Z</dcterms:modified>
  <cp:revision>9</cp:revision>
  <dc:subject/>
  <dc:title>Slide 1</dc:title>
</cp:coreProperties>
</file>